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493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57"/>
    <p:restoredTop sz="83537"/>
  </p:normalViewPr>
  <p:slideViewPr>
    <p:cSldViewPr snapToGrid="0" snapToObjects="1">
      <p:cViewPr varScale="1">
        <p:scale>
          <a:sx n="106" d="100"/>
          <a:sy n="106" d="100"/>
        </p:scale>
        <p:origin x="268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76DCF3-F0C5-6746-881E-A6414B0DBC78}" type="datetimeFigureOut">
              <a:rPr lang="en-US" smtClean="0"/>
              <a:t>2/15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650031-787D-F84F-B24B-E5E8DF1249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6294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9650031-787D-F84F-B24B-E5E8DF12492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1593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8537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457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07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53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6503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266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079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98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618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344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7747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F5D764-F429-8045-8A65-90902041B000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CB287-AA74-C842-AB15-CDFDA609B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001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emf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emf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emf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74C9D91-C423-E242-85DB-A3674DB0CB0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24" t="13431" r="9449" b="20415"/>
          <a:stretch/>
        </p:blipFill>
        <p:spPr>
          <a:xfrm>
            <a:off x="4052040" y="2355457"/>
            <a:ext cx="472471" cy="380050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8ACE039F-5765-4B43-81D3-DAEF07963C1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895" b="21681"/>
          <a:stretch/>
        </p:blipFill>
        <p:spPr>
          <a:xfrm>
            <a:off x="4516506" y="2355457"/>
            <a:ext cx="503878" cy="380050"/>
          </a:xfrm>
          <a:prstGeom prst="rect">
            <a:avLst/>
          </a:prstGeom>
        </p:spPr>
      </p:pic>
      <p:pic>
        <p:nvPicPr>
          <p:cNvPr id="102" name="Picture 101">
            <a:extLst>
              <a:ext uri="{FF2B5EF4-FFF2-40B4-BE49-F238E27FC236}">
                <a16:creationId xmlns:a16="http://schemas.microsoft.com/office/drawing/2014/main" id="{C09A7692-6347-B84C-AD37-0D0815F654F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14" t="63085" b="5591"/>
          <a:stretch/>
        </p:blipFill>
        <p:spPr>
          <a:xfrm>
            <a:off x="1905320" y="2858258"/>
            <a:ext cx="900249" cy="300534"/>
          </a:xfrm>
          <a:prstGeom prst="rect">
            <a:avLst/>
          </a:prstGeom>
        </p:spPr>
      </p:pic>
      <p:pic>
        <p:nvPicPr>
          <p:cNvPr id="101" name="Picture 100">
            <a:extLst>
              <a:ext uri="{FF2B5EF4-FFF2-40B4-BE49-F238E27FC236}">
                <a16:creationId xmlns:a16="http://schemas.microsoft.com/office/drawing/2014/main" id="{110E2D5C-BDC0-E440-8E9C-797830B9B0B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14" t="63085" r="47639" b="5591"/>
          <a:stretch/>
        </p:blipFill>
        <p:spPr>
          <a:xfrm>
            <a:off x="822861" y="2856189"/>
            <a:ext cx="976439" cy="300534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C2755EBD-4FBD-9446-8F6A-53FBE6979B3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8158"/>
          <a:stretch/>
        </p:blipFill>
        <p:spPr>
          <a:xfrm>
            <a:off x="1898857" y="2038390"/>
            <a:ext cx="900249" cy="278109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B1498BB5-58CC-4549-8861-D0FD84739B8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48158"/>
          <a:stretch/>
        </p:blipFill>
        <p:spPr>
          <a:xfrm>
            <a:off x="836474" y="2040988"/>
            <a:ext cx="958837" cy="278109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06425682-2CC7-EC43-A8D8-58FBA35E995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28798"/>
          <a:stretch/>
        </p:blipFill>
        <p:spPr>
          <a:xfrm>
            <a:off x="358778" y="3585001"/>
            <a:ext cx="1640242" cy="1672276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B2141126-C271-044C-A663-6FECC40413E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28145"/>
          <a:stretch/>
        </p:blipFill>
        <p:spPr>
          <a:xfrm>
            <a:off x="3628225" y="3582037"/>
            <a:ext cx="1673453" cy="167820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0AD76D66-8EE7-A44E-A684-FA99A2BAE14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r="32208"/>
          <a:stretch/>
        </p:blipFill>
        <p:spPr>
          <a:xfrm>
            <a:off x="2032338" y="3582037"/>
            <a:ext cx="1610314" cy="168116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3B98CEE0-B9CD-3446-823D-8E71EB1AC76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326357" y="3582037"/>
            <a:ext cx="2322193" cy="167833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71210E5-A8EF-CE4C-B3C6-468FC9C66C6F}"/>
              </a:ext>
            </a:extLst>
          </p:cNvPr>
          <p:cNvSpPr txBox="1"/>
          <p:nvPr/>
        </p:nvSpPr>
        <p:spPr>
          <a:xfrm>
            <a:off x="153208" y="78215"/>
            <a:ext cx="9226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21D2908-033F-9942-8569-1A5E50424AF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435" t="39198" r="9091" b="18907"/>
          <a:stretch/>
        </p:blipFill>
        <p:spPr>
          <a:xfrm>
            <a:off x="825063" y="2348641"/>
            <a:ext cx="517536" cy="469972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4D01A9B-3E9F-C04F-A44C-9D0E93E10CB0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3" t="39198" r="74623" b="16099"/>
          <a:stretch/>
        </p:blipFill>
        <p:spPr>
          <a:xfrm>
            <a:off x="1334665" y="2353788"/>
            <a:ext cx="468848" cy="46482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ED611FB-6329-7240-ABA0-D097FE2EA859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10" t="38144" r="42566" b="17153"/>
          <a:stretch/>
        </p:blipFill>
        <p:spPr>
          <a:xfrm flipH="1">
            <a:off x="1905320" y="2359128"/>
            <a:ext cx="900249" cy="431223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D98BC8E-C613-074A-82B5-B3648CFB8D98}"/>
              </a:ext>
            </a:extLst>
          </p:cNvPr>
          <p:cNvSpPr txBox="1"/>
          <p:nvPr/>
        </p:nvSpPr>
        <p:spPr>
          <a:xfrm>
            <a:off x="1045953" y="1206139"/>
            <a:ext cx="609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ad C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04C9417-CC96-9D4E-ADBE-192EE3CFC08B}"/>
              </a:ext>
            </a:extLst>
          </p:cNvPr>
          <p:cNvSpPr txBox="1"/>
          <p:nvPr/>
        </p:nvSpPr>
        <p:spPr>
          <a:xfrm>
            <a:off x="2037255" y="1201684"/>
            <a:ext cx="609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ad RL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192BBFB6-B9F1-1C49-9FAD-D132E77C201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979" t="50958" r="16951" b="8163"/>
          <a:stretch/>
        </p:blipFill>
        <p:spPr>
          <a:xfrm>
            <a:off x="822861" y="1624557"/>
            <a:ext cx="515525" cy="389338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F5AD0DD-DB34-654F-B568-D9AA216C352B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3" t="50958" r="83704" b="8163"/>
          <a:stretch/>
        </p:blipFill>
        <p:spPr>
          <a:xfrm>
            <a:off x="1330452" y="1625243"/>
            <a:ext cx="468848" cy="3886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DC3AA5E-2F52-1548-8B05-AAD274FB4038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12" t="50958" r="42608" b="8163"/>
          <a:stretch/>
        </p:blipFill>
        <p:spPr>
          <a:xfrm flipH="1">
            <a:off x="1898857" y="1632670"/>
            <a:ext cx="900249" cy="38821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CB91489A-7A40-494E-890B-99F2E23F5ADF}"/>
              </a:ext>
            </a:extLst>
          </p:cNvPr>
          <p:cNvSpPr txBox="1"/>
          <p:nvPr/>
        </p:nvSpPr>
        <p:spPr>
          <a:xfrm>
            <a:off x="281782" y="2473163"/>
            <a:ext cx="5222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NCX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87FFE44-D434-A84F-84C4-F65758014A1F}"/>
              </a:ext>
            </a:extLst>
          </p:cNvPr>
          <p:cNvSpPr txBox="1"/>
          <p:nvPr/>
        </p:nvSpPr>
        <p:spPr>
          <a:xfrm>
            <a:off x="273580" y="1706285"/>
            <a:ext cx="5353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MC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3B4CFF8-C566-5342-9ECC-F8014BD6CE22}"/>
              </a:ext>
            </a:extLst>
          </p:cNvPr>
          <p:cNvSpPr txBox="1"/>
          <p:nvPr/>
        </p:nvSpPr>
        <p:spPr>
          <a:xfrm>
            <a:off x="278089" y="2881958"/>
            <a:ext cx="558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656DFBA-E2D9-0442-90DC-D08FB6A6E6B1}"/>
              </a:ext>
            </a:extLst>
          </p:cNvPr>
          <p:cNvSpPr txBox="1"/>
          <p:nvPr/>
        </p:nvSpPr>
        <p:spPr>
          <a:xfrm>
            <a:off x="2807308" y="2912512"/>
            <a:ext cx="538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7992347-A9F1-3B4D-BAD7-66EA851A75CE}"/>
              </a:ext>
            </a:extLst>
          </p:cNvPr>
          <p:cNvSpPr txBox="1"/>
          <p:nvPr/>
        </p:nvSpPr>
        <p:spPr>
          <a:xfrm>
            <a:off x="2799106" y="1728243"/>
            <a:ext cx="648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5134514-C6F7-1F47-9B31-73B7B0FD1F6A}"/>
              </a:ext>
            </a:extLst>
          </p:cNvPr>
          <p:cNvSpPr txBox="1"/>
          <p:nvPr/>
        </p:nvSpPr>
        <p:spPr>
          <a:xfrm>
            <a:off x="2807308" y="2475569"/>
            <a:ext cx="615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A66C576-745E-6346-B636-F316528D081D}"/>
              </a:ext>
            </a:extLst>
          </p:cNvPr>
          <p:cNvSpPr txBox="1"/>
          <p:nvPr/>
        </p:nvSpPr>
        <p:spPr>
          <a:xfrm>
            <a:off x="828271" y="1632670"/>
            <a:ext cx="967040" cy="36933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7D6A54E-9F4A-9548-98CD-F442B3A3FECE}"/>
              </a:ext>
            </a:extLst>
          </p:cNvPr>
          <p:cNvSpPr txBox="1"/>
          <p:nvPr/>
        </p:nvSpPr>
        <p:spPr>
          <a:xfrm>
            <a:off x="822861" y="2350053"/>
            <a:ext cx="980652" cy="46166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2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DD67036-D17E-7248-A68A-637884625075}"/>
              </a:ext>
            </a:extLst>
          </p:cNvPr>
          <p:cNvSpPr txBox="1"/>
          <p:nvPr/>
        </p:nvSpPr>
        <p:spPr>
          <a:xfrm>
            <a:off x="812916" y="1388815"/>
            <a:ext cx="1405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  Sed         VWR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C7BF2A3C-7727-E44E-81BE-7E19A64CB23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7097" t="41284" r="85566" b="28047"/>
          <a:stretch/>
        </p:blipFill>
        <p:spPr>
          <a:xfrm>
            <a:off x="4050657" y="1628999"/>
            <a:ext cx="498716" cy="326453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06E4FB30-E31D-174C-84DD-B86EDE1B1B13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3237" t="43448" r="39236" b="27681"/>
          <a:stretch/>
        </p:blipFill>
        <p:spPr>
          <a:xfrm>
            <a:off x="4515368" y="1630401"/>
            <a:ext cx="507534" cy="330232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3A9FECE5-5BD7-994C-9DF9-1E31BEE4B830}"/>
              </a:ext>
            </a:extLst>
          </p:cNvPr>
          <p:cNvSpPr txBox="1"/>
          <p:nvPr/>
        </p:nvSpPr>
        <p:spPr>
          <a:xfrm>
            <a:off x="4051962" y="1621131"/>
            <a:ext cx="967040" cy="33855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6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08833F9-F19D-EF46-AACF-DDC965AD3927}"/>
              </a:ext>
            </a:extLst>
          </p:cNvPr>
          <p:cNvSpPr txBox="1"/>
          <p:nvPr/>
        </p:nvSpPr>
        <p:spPr>
          <a:xfrm>
            <a:off x="3493738" y="1676851"/>
            <a:ext cx="6122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ERC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9E2681A-2C4F-5148-AA56-8903DBDB0A4B}"/>
              </a:ext>
            </a:extLst>
          </p:cNvPr>
          <p:cNvSpPr txBox="1"/>
          <p:nvPr/>
        </p:nvSpPr>
        <p:spPr>
          <a:xfrm>
            <a:off x="6027674" y="1697467"/>
            <a:ext cx="648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1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A8F4A77-FBDE-3E47-9FF3-1E179A6F0A89}"/>
              </a:ext>
            </a:extLst>
          </p:cNvPr>
          <p:cNvSpPr txBox="1"/>
          <p:nvPr/>
        </p:nvSpPr>
        <p:spPr>
          <a:xfrm>
            <a:off x="286127" y="1122258"/>
            <a:ext cx="3775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E22E687-95BC-AC43-9F04-D891BDD5F777}"/>
              </a:ext>
            </a:extLst>
          </p:cNvPr>
          <p:cNvSpPr txBox="1"/>
          <p:nvPr/>
        </p:nvSpPr>
        <p:spPr>
          <a:xfrm>
            <a:off x="306434" y="3431672"/>
            <a:ext cx="3775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9CBBD2C-D117-5646-AF7D-377C9665F050}"/>
              </a:ext>
            </a:extLst>
          </p:cNvPr>
          <p:cNvSpPr txBox="1"/>
          <p:nvPr/>
        </p:nvSpPr>
        <p:spPr>
          <a:xfrm>
            <a:off x="2011360" y="3431672"/>
            <a:ext cx="3775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c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1159451-0627-8C49-90F7-C998720DC98C}"/>
              </a:ext>
            </a:extLst>
          </p:cNvPr>
          <p:cNvSpPr txBox="1"/>
          <p:nvPr/>
        </p:nvSpPr>
        <p:spPr>
          <a:xfrm>
            <a:off x="3422307" y="1122258"/>
            <a:ext cx="3775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d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FB59A19-BB62-5D4E-9247-1C67E9B9A776}"/>
              </a:ext>
            </a:extLst>
          </p:cNvPr>
          <p:cNvSpPr txBox="1"/>
          <p:nvPr/>
        </p:nvSpPr>
        <p:spPr>
          <a:xfrm>
            <a:off x="3504177" y="2044491"/>
            <a:ext cx="682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A670DA1-A368-9B42-B59A-A447D03357C8}"/>
              </a:ext>
            </a:extLst>
          </p:cNvPr>
          <p:cNvSpPr txBox="1"/>
          <p:nvPr/>
        </p:nvSpPr>
        <p:spPr>
          <a:xfrm>
            <a:off x="6062040" y="2043584"/>
            <a:ext cx="6158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AE5771C-49DD-1D46-A89C-96EED0382D86}"/>
              </a:ext>
            </a:extLst>
          </p:cNvPr>
          <p:cNvSpPr txBox="1"/>
          <p:nvPr/>
        </p:nvSpPr>
        <p:spPr>
          <a:xfrm>
            <a:off x="3514368" y="2455010"/>
            <a:ext cx="6824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CU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1BB087E-D863-524E-A0EF-E727737C304E}"/>
              </a:ext>
            </a:extLst>
          </p:cNvPr>
          <p:cNvSpPr txBox="1"/>
          <p:nvPr/>
        </p:nvSpPr>
        <p:spPr>
          <a:xfrm>
            <a:off x="6037314" y="2421339"/>
            <a:ext cx="5527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FC6214AD-C07A-6C4A-B75F-6C0A3F2ACAF8}"/>
              </a:ext>
            </a:extLst>
          </p:cNvPr>
          <p:cNvSpPr txBox="1"/>
          <p:nvPr/>
        </p:nvSpPr>
        <p:spPr>
          <a:xfrm>
            <a:off x="4288494" y="1250765"/>
            <a:ext cx="615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ad CL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FBEB9FC2-F97C-584B-A3CC-B99F57B0A61A}"/>
              </a:ext>
            </a:extLst>
          </p:cNvPr>
          <p:cNvSpPr txBox="1"/>
          <p:nvPr/>
        </p:nvSpPr>
        <p:spPr>
          <a:xfrm>
            <a:off x="4147149" y="1436410"/>
            <a:ext cx="8790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ed       VWR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18397F5-D351-7048-8500-96B273CF3C27}"/>
              </a:ext>
            </a:extLst>
          </p:cNvPr>
          <p:cNvSpPr txBox="1"/>
          <p:nvPr/>
        </p:nvSpPr>
        <p:spPr>
          <a:xfrm>
            <a:off x="3687610" y="3431671"/>
            <a:ext cx="3775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e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AC6F566-9055-6D4C-B10A-B34C98B7C434}"/>
              </a:ext>
            </a:extLst>
          </p:cNvPr>
          <p:cNvSpPr txBox="1"/>
          <p:nvPr/>
        </p:nvSpPr>
        <p:spPr>
          <a:xfrm>
            <a:off x="5305851" y="3431671"/>
            <a:ext cx="3775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400" dirty="0"/>
              <a:t>f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CF8AABD-6623-914C-89A0-EBC12A63E5E6}"/>
              </a:ext>
            </a:extLst>
          </p:cNvPr>
          <p:cNvSpPr txBox="1"/>
          <p:nvPr/>
        </p:nvSpPr>
        <p:spPr>
          <a:xfrm>
            <a:off x="5248249" y="1249692"/>
            <a:ext cx="6155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ad RL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AD603D5-44E0-1D46-8584-F5B69D0BEC38}"/>
              </a:ext>
            </a:extLst>
          </p:cNvPr>
          <p:cNvSpPr txBox="1"/>
          <p:nvPr/>
        </p:nvSpPr>
        <p:spPr>
          <a:xfrm>
            <a:off x="1868290" y="1384197"/>
            <a:ext cx="14057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 Sed         VWR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D114590-4D18-0841-947A-AD106A0F0353}"/>
              </a:ext>
            </a:extLst>
          </p:cNvPr>
          <p:cNvSpPr txBox="1"/>
          <p:nvPr/>
        </p:nvSpPr>
        <p:spPr>
          <a:xfrm>
            <a:off x="5146955" y="1430704"/>
            <a:ext cx="8790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ed       VWR</a:t>
            </a: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21BA09AF-97BC-EB47-8041-D3F7CD60066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6201" t="7211" r="3492" b="24027"/>
          <a:stretch/>
        </p:blipFill>
        <p:spPr>
          <a:xfrm>
            <a:off x="1361853" y="2051514"/>
            <a:ext cx="367455" cy="224085"/>
          </a:xfrm>
          <a:prstGeom prst="rect">
            <a:avLst/>
          </a:prstGeom>
        </p:spPr>
      </p:pic>
      <p:pic>
        <p:nvPicPr>
          <p:cNvPr id="79" name="Picture 78">
            <a:extLst>
              <a:ext uri="{FF2B5EF4-FFF2-40B4-BE49-F238E27FC236}">
                <a16:creationId xmlns:a16="http://schemas.microsoft.com/office/drawing/2014/main" id="{BE875CCA-2013-6C40-B9DA-AD54FED9483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316" t="1413" r="3334" b="40558"/>
          <a:stretch/>
        </p:blipFill>
        <p:spPr>
          <a:xfrm>
            <a:off x="890165" y="2043004"/>
            <a:ext cx="399332" cy="229988"/>
          </a:xfrm>
          <a:prstGeom prst="rect">
            <a:avLst/>
          </a:prstGeom>
        </p:spPr>
      </p:pic>
      <p:pic>
        <p:nvPicPr>
          <p:cNvPr id="81" name="Picture 80">
            <a:extLst>
              <a:ext uri="{FF2B5EF4-FFF2-40B4-BE49-F238E27FC236}">
                <a16:creationId xmlns:a16="http://schemas.microsoft.com/office/drawing/2014/main" id="{B43A16B0-E29C-1245-8A96-19B57822D784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r="6374" b="25171"/>
          <a:stretch/>
        </p:blipFill>
        <p:spPr>
          <a:xfrm>
            <a:off x="1931611" y="2055003"/>
            <a:ext cx="368300" cy="224084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C4CD2B34-8A5B-A54C-837F-19365F53FFF4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4538" r="6480" b="33890"/>
          <a:stretch/>
        </p:blipFill>
        <p:spPr>
          <a:xfrm>
            <a:off x="2381818" y="2063974"/>
            <a:ext cx="347701" cy="215444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1D1A0260-0901-2B4D-BFE4-3702C75E3A1C}"/>
              </a:ext>
            </a:extLst>
          </p:cNvPr>
          <p:cNvSpPr txBox="1"/>
          <p:nvPr/>
        </p:nvSpPr>
        <p:spPr>
          <a:xfrm>
            <a:off x="837806" y="2043510"/>
            <a:ext cx="957505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158BA08B-87CF-5A42-8311-9AFD5878085E}"/>
              </a:ext>
            </a:extLst>
          </p:cNvPr>
          <p:cNvSpPr txBox="1"/>
          <p:nvPr/>
        </p:nvSpPr>
        <p:spPr>
          <a:xfrm>
            <a:off x="1896412" y="2043509"/>
            <a:ext cx="910896" cy="27699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5366684-C763-1243-8F93-8C21ECD728B3}"/>
              </a:ext>
            </a:extLst>
          </p:cNvPr>
          <p:cNvSpPr txBox="1"/>
          <p:nvPr/>
        </p:nvSpPr>
        <p:spPr>
          <a:xfrm>
            <a:off x="270155" y="2051303"/>
            <a:ext cx="5583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6195D84-92EF-B14D-A41C-AED7104A598F}"/>
              </a:ext>
            </a:extLst>
          </p:cNvPr>
          <p:cNvSpPr txBox="1"/>
          <p:nvPr/>
        </p:nvSpPr>
        <p:spPr>
          <a:xfrm>
            <a:off x="2803782" y="2072289"/>
            <a:ext cx="5389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pic>
        <p:nvPicPr>
          <p:cNvPr id="92" name="Picture 91">
            <a:extLst>
              <a:ext uri="{FF2B5EF4-FFF2-40B4-BE49-F238E27FC236}">
                <a16:creationId xmlns:a16="http://schemas.microsoft.com/office/drawing/2014/main" id="{2E024831-46D0-464D-BA75-7904D723C2E0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6910" t="12978" r="6507" b="28077"/>
          <a:stretch/>
        </p:blipFill>
        <p:spPr>
          <a:xfrm>
            <a:off x="890165" y="2889553"/>
            <a:ext cx="371416" cy="256550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F36D8EC3-A742-F946-992A-5F225C7937DB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3125" t="15857" r="4407" b="23917"/>
          <a:stretch/>
        </p:blipFill>
        <p:spPr>
          <a:xfrm>
            <a:off x="1385853" y="2889552"/>
            <a:ext cx="409458" cy="256550"/>
          </a:xfrm>
          <a:prstGeom prst="rect">
            <a:avLst/>
          </a:prstGeom>
        </p:spPr>
      </p:pic>
      <p:pic>
        <p:nvPicPr>
          <p:cNvPr id="96" name="Picture 95">
            <a:extLst>
              <a:ext uri="{FF2B5EF4-FFF2-40B4-BE49-F238E27FC236}">
                <a16:creationId xmlns:a16="http://schemas.microsoft.com/office/drawing/2014/main" id="{62B00456-12EB-8A4D-9C74-EA7B41366DF6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1370" t="12346" r="7685" b="22852"/>
          <a:stretch/>
        </p:blipFill>
        <p:spPr>
          <a:xfrm>
            <a:off x="1930939" y="2894061"/>
            <a:ext cx="377548" cy="252042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D3E41F47-AE77-5D4E-9AB4-BF4A075FCB9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14" t="17757" b="21976"/>
          <a:stretch/>
        </p:blipFill>
        <p:spPr>
          <a:xfrm>
            <a:off x="2406649" y="2894060"/>
            <a:ext cx="402315" cy="251149"/>
          </a:xfrm>
          <a:prstGeom prst="rect">
            <a:avLst/>
          </a:prstGeom>
        </p:spPr>
      </p:pic>
      <p:sp>
        <p:nvSpPr>
          <p:cNvPr id="99" name="TextBox 98">
            <a:extLst>
              <a:ext uri="{FF2B5EF4-FFF2-40B4-BE49-F238E27FC236}">
                <a16:creationId xmlns:a16="http://schemas.microsoft.com/office/drawing/2014/main" id="{8B6B266C-4D64-EC4C-A56F-DA1FB5530A29}"/>
              </a:ext>
            </a:extLst>
          </p:cNvPr>
          <p:cNvSpPr txBox="1"/>
          <p:nvPr/>
        </p:nvSpPr>
        <p:spPr>
          <a:xfrm>
            <a:off x="819866" y="2858787"/>
            <a:ext cx="983648" cy="3077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E26E3FD4-AA53-174C-A29E-29054D138106}"/>
              </a:ext>
            </a:extLst>
          </p:cNvPr>
          <p:cNvSpPr txBox="1"/>
          <p:nvPr/>
        </p:nvSpPr>
        <p:spPr>
          <a:xfrm>
            <a:off x="1900372" y="2858787"/>
            <a:ext cx="905197" cy="3077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400" dirty="0"/>
          </a:p>
        </p:txBody>
      </p:sp>
      <p:pic>
        <p:nvPicPr>
          <p:cNvPr id="105" name="Picture 104">
            <a:extLst>
              <a:ext uri="{FF2B5EF4-FFF2-40B4-BE49-F238E27FC236}">
                <a16:creationId xmlns:a16="http://schemas.microsoft.com/office/drawing/2014/main" id="{0498C109-6E02-A64A-968D-5795EB449D92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t="13275" r="2141" b="20773"/>
          <a:stretch/>
        </p:blipFill>
        <p:spPr>
          <a:xfrm>
            <a:off x="4071631" y="2002374"/>
            <a:ext cx="450047" cy="309905"/>
          </a:xfrm>
          <a:prstGeom prst="rect">
            <a:avLst/>
          </a:prstGeom>
        </p:spPr>
      </p:pic>
      <p:pic>
        <p:nvPicPr>
          <p:cNvPr id="109" name="Picture 108">
            <a:extLst>
              <a:ext uri="{FF2B5EF4-FFF2-40B4-BE49-F238E27FC236}">
                <a16:creationId xmlns:a16="http://schemas.microsoft.com/office/drawing/2014/main" id="{794DE991-6A99-6E46-B05C-11D512D2DB52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t="9994" b="10042"/>
          <a:stretch/>
        </p:blipFill>
        <p:spPr>
          <a:xfrm>
            <a:off x="5073586" y="1624557"/>
            <a:ext cx="469629" cy="335128"/>
          </a:xfrm>
          <a:prstGeom prst="rect">
            <a:avLst/>
          </a:prstGeom>
        </p:spPr>
      </p:pic>
      <p:pic>
        <p:nvPicPr>
          <p:cNvPr id="111" name="Picture 110">
            <a:extLst>
              <a:ext uri="{FF2B5EF4-FFF2-40B4-BE49-F238E27FC236}">
                <a16:creationId xmlns:a16="http://schemas.microsoft.com/office/drawing/2014/main" id="{FE02F8FF-96F1-0647-ABEC-B6DAB1D93D68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t="8882" b="18851"/>
          <a:stretch/>
        </p:blipFill>
        <p:spPr>
          <a:xfrm>
            <a:off x="5083013" y="2009407"/>
            <a:ext cx="451762" cy="302872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41A35DA1-D679-1749-8190-48032B47A2F3}"/>
              </a:ext>
            </a:extLst>
          </p:cNvPr>
          <p:cNvSpPr txBox="1"/>
          <p:nvPr/>
        </p:nvSpPr>
        <p:spPr>
          <a:xfrm>
            <a:off x="4050657" y="2344370"/>
            <a:ext cx="969698" cy="40011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2000" dirty="0"/>
          </a:p>
        </p:txBody>
      </p:sp>
      <p:pic>
        <p:nvPicPr>
          <p:cNvPr id="115" name="Picture 114">
            <a:extLst>
              <a:ext uri="{FF2B5EF4-FFF2-40B4-BE49-F238E27FC236}">
                <a16:creationId xmlns:a16="http://schemas.microsoft.com/office/drawing/2014/main" id="{E6FAC671-6B03-8841-936D-C2B66C6DEDD3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l="3854" t="8870" r="4093" b="20987"/>
          <a:stretch/>
        </p:blipFill>
        <p:spPr>
          <a:xfrm>
            <a:off x="4521678" y="2004780"/>
            <a:ext cx="487868" cy="302872"/>
          </a:xfrm>
          <a:prstGeom prst="rect">
            <a:avLst/>
          </a:prstGeom>
        </p:spPr>
      </p:pic>
      <p:pic>
        <p:nvPicPr>
          <p:cNvPr id="117" name="Picture 116">
            <a:extLst>
              <a:ext uri="{FF2B5EF4-FFF2-40B4-BE49-F238E27FC236}">
                <a16:creationId xmlns:a16="http://schemas.microsoft.com/office/drawing/2014/main" id="{A5AF7D99-D95D-BA47-918D-72240C9ECAC0}"/>
              </a:ext>
            </a:extLst>
          </p:cNvPr>
          <p:cNvPicPr>
            <a:picLocks noChangeAspect="1"/>
          </p:cNvPicPr>
          <p:nvPr/>
        </p:nvPicPr>
        <p:blipFill rotWithShape="1">
          <a:blip r:embed="rId24"/>
          <a:srcRect t="20194" b="9388"/>
          <a:stretch/>
        </p:blipFill>
        <p:spPr>
          <a:xfrm>
            <a:off x="5526506" y="1624556"/>
            <a:ext cx="469629" cy="330896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F517701F-82B8-D44B-BC6B-E0B9E0BB5C81}"/>
              </a:ext>
            </a:extLst>
          </p:cNvPr>
          <p:cNvPicPr>
            <a:picLocks noChangeAspect="1"/>
          </p:cNvPicPr>
          <p:nvPr/>
        </p:nvPicPr>
        <p:blipFill rotWithShape="1">
          <a:blip r:embed="rId25"/>
          <a:srcRect t="5505" b="19969"/>
          <a:stretch/>
        </p:blipFill>
        <p:spPr>
          <a:xfrm>
            <a:off x="5534775" y="2009407"/>
            <a:ext cx="467670" cy="302872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FE849412-B597-7E4B-A27A-AD8CBFC96695}"/>
              </a:ext>
            </a:extLst>
          </p:cNvPr>
          <p:cNvSpPr txBox="1"/>
          <p:nvPr/>
        </p:nvSpPr>
        <p:spPr>
          <a:xfrm>
            <a:off x="5069534" y="1624555"/>
            <a:ext cx="910345" cy="33855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6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B74DF14-32BA-5047-8A0C-AC261384F361}"/>
              </a:ext>
            </a:extLst>
          </p:cNvPr>
          <p:cNvSpPr txBox="1"/>
          <p:nvPr/>
        </p:nvSpPr>
        <p:spPr>
          <a:xfrm>
            <a:off x="4069892" y="1993994"/>
            <a:ext cx="939654" cy="31828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20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7B306C90-836F-F842-8302-16304E79A4ED}"/>
              </a:ext>
            </a:extLst>
          </p:cNvPr>
          <p:cNvSpPr txBox="1"/>
          <p:nvPr/>
        </p:nvSpPr>
        <p:spPr>
          <a:xfrm>
            <a:off x="5081020" y="2002374"/>
            <a:ext cx="921425" cy="3077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4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0B83A36-6808-AD42-96D0-62A5F220FCB8}"/>
              </a:ext>
            </a:extLst>
          </p:cNvPr>
          <p:cNvSpPr txBox="1"/>
          <p:nvPr/>
        </p:nvSpPr>
        <p:spPr>
          <a:xfrm>
            <a:off x="2807837" y="1511163"/>
            <a:ext cx="648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7BE961C-E81E-F54E-8168-8A16E31C5978}"/>
              </a:ext>
            </a:extLst>
          </p:cNvPr>
          <p:cNvSpPr txBox="1"/>
          <p:nvPr/>
        </p:nvSpPr>
        <p:spPr>
          <a:xfrm>
            <a:off x="6025090" y="1468016"/>
            <a:ext cx="6489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124717BB-F7A8-DC40-B484-170B19ACC9EB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t="7416" b="10126"/>
          <a:stretch/>
        </p:blipFill>
        <p:spPr>
          <a:xfrm>
            <a:off x="4069892" y="2795036"/>
            <a:ext cx="474974" cy="31790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892315C-4DC5-1A4F-BCBD-C727004C1FB8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t="8652" b="18963"/>
          <a:stretch/>
        </p:blipFill>
        <p:spPr>
          <a:xfrm>
            <a:off x="5076153" y="2344370"/>
            <a:ext cx="534326" cy="40011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88B1D0D9-7CD0-5042-8FC0-1800B3AEDE03}"/>
              </a:ext>
            </a:extLst>
          </p:cNvPr>
          <p:cNvPicPr>
            <a:picLocks noChangeAspect="1"/>
          </p:cNvPicPr>
          <p:nvPr/>
        </p:nvPicPr>
        <p:blipFill rotWithShape="1">
          <a:blip r:embed="rId28"/>
          <a:srcRect b="14016"/>
          <a:stretch/>
        </p:blipFill>
        <p:spPr>
          <a:xfrm>
            <a:off x="5081059" y="2795094"/>
            <a:ext cx="453716" cy="31790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5A551A88-E3C4-1F43-95AE-C06B2F9A2F28}"/>
              </a:ext>
            </a:extLst>
          </p:cNvPr>
          <p:cNvPicPr>
            <a:picLocks noChangeAspect="1"/>
          </p:cNvPicPr>
          <p:nvPr/>
        </p:nvPicPr>
        <p:blipFill rotWithShape="1">
          <a:blip r:embed="rId29"/>
          <a:srcRect t="5762" b="20860"/>
          <a:stretch/>
        </p:blipFill>
        <p:spPr>
          <a:xfrm>
            <a:off x="4544439" y="2797182"/>
            <a:ext cx="465990" cy="315755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59B36AAD-A516-1F49-975E-7006CA3C9B99}"/>
              </a:ext>
            </a:extLst>
          </p:cNvPr>
          <p:cNvPicPr>
            <a:picLocks noChangeAspect="1"/>
          </p:cNvPicPr>
          <p:nvPr/>
        </p:nvPicPr>
        <p:blipFill rotWithShape="1">
          <a:blip r:embed="rId30"/>
          <a:srcRect l="6447" t="7614" r="9114" b="18851"/>
          <a:stretch/>
        </p:blipFill>
        <p:spPr>
          <a:xfrm>
            <a:off x="5555796" y="2348641"/>
            <a:ext cx="440339" cy="39584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26E468A-FD26-8848-B09B-8BFF2386F49D}"/>
              </a:ext>
            </a:extLst>
          </p:cNvPr>
          <p:cNvPicPr>
            <a:picLocks noChangeAspect="1"/>
          </p:cNvPicPr>
          <p:nvPr/>
        </p:nvPicPr>
        <p:blipFill rotWithShape="1">
          <a:blip r:embed="rId31"/>
          <a:srcRect l="-1" t="9874" r="3910" b="10072"/>
          <a:stretch/>
        </p:blipFill>
        <p:spPr>
          <a:xfrm>
            <a:off x="5534775" y="2797241"/>
            <a:ext cx="453716" cy="315754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1D52FED2-A41D-414C-9AB0-8E6065D78419}"/>
              </a:ext>
            </a:extLst>
          </p:cNvPr>
          <p:cNvSpPr txBox="1"/>
          <p:nvPr/>
        </p:nvSpPr>
        <p:spPr>
          <a:xfrm>
            <a:off x="5069534" y="2347059"/>
            <a:ext cx="919523" cy="40011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20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144591BF-622F-5741-B6E8-237E56A7128F}"/>
              </a:ext>
            </a:extLst>
          </p:cNvPr>
          <p:cNvSpPr txBox="1"/>
          <p:nvPr/>
        </p:nvSpPr>
        <p:spPr>
          <a:xfrm>
            <a:off x="4063706" y="2793008"/>
            <a:ext cx="949110" cy="32316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5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F6A8A27-3DA4-834B-9A9A-71303D99AFA3}"/>
              </a:ext>
            </a:extLst>
          </p:cNvPr>
          <p:cNvSpPr txBox="1"/>
          <p:nvPr/>
        </p:nvSpPr>
        <p:spPr>
          <a:xfrm>
            <a:off x="5073244" y="2793008"/>
            <a:ext cx="921425" cy="323165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sz="1500" dirty="0"/>
          </a:p>
        </p:txBody>
      </p:sp>
    </p:spTree>
    <p:extLst>
      <p:ext uri="{BB962C8B-B14F-4D97-AF65-F5344CB8AC3E}">
        <p14:creationId xmlns:p14="http://schemas.microsoft.com/office/powerpoint/2010/main" val="2736849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493</TotalTime>
  <Words>44</Words>
  <Application>Microsoft Macintosh PowerPoint</Application>
  <PresentationFormat>On-screen Show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Joe V Chakkalakal, Ph.D.</cp:lastModifiedBy>
  <cp:revision>455</cp:revision>
  <dcterms:created xsi:type="dcterms:W3CDTF">2021-03-04T16:31:45Z</dcterms:created>
  <dcterms:modified xsi:type="dcterms:W3CDTF">2022-02-15T16:14:16Z</dcterms:modified>
  <cp:category/>
</cp:coreProperties>
</file>